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7"/>
    <p:restoredTop sz="94694"/>
  </p:normalViewPr>
  <p:slideViewPr>
    <p:cSldViewPr snapToGrid="0" snapToObjects="1">
      <p:cViewPr varScale="1">
        <p:scale>
          <a:sx n="63" d="100"/>
          <a:sy n="63" d="100"/>
        </p:scale>
        <p:origin x="7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7E2EFB-7538-C449-B146-E0F889F9FA35}" type="datetimeFigureOut">
              <a:rPr lang="en-US" smtClean="0"/>
              <a:t>9/26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5540FA-66FB-8E49-A138-071E33AC6D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5200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. Average DNA methylation change within individuals between low altitude (1400m) and high altitude (3440m, 4240m and 5160m combined). Each individual is listed as a colored and numbered line. The dashed line indicates baseline methylation at low altitude (1400m).  A) LINE-1; B)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PAS1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C)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PO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D)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PAR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; E)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XRa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F644838-ED99-0F45-9EAA-B88AB6726C6C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7047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</a:t>
            </a:r>
            <a:r>
              <a:rPr lang="en-US" baseline="0" dirty="0"/>
              <a:t> Figure 2</a:t>
            </a:r>
            <a:r>
              <a:rPr lang="en-US" dirty="0"/>
              <a:t>. (A) RXRa methylation values</a:t>
            </a:r>
            <a:r>
              <a:rPr lang="en-US" baseline="0" dirty="0"/>
              <a:t> plotted against hemoglobin levels for each altitude separately; (B) EPAS1 </a:t>
            </a:r>
            <a:r>
              <a:rPr lang="en-US" dirty="0"/>
              <a:t>methylation values</a:t>
            </a:r>
            <a:r>
              <a:rPr lang="en-US" baseline="0" dirty="0"/>
              <a:t> plotted against systolic blood pressure for each altitude separately. 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=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400 (BL),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2 =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3440m (Day 3), 3 =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4240m (Day 7), 4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=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5160m (Day 10)</a:t>
            </a:r>
            <a:endParaRPr lang="en-US" baseline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F644838-ED99-0F45-9EAA-B88AB6726C6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50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4750B-DF4D-1C4A-B1E1-4DFC72D2C6DC}" type="datetimeFigureOut">
              <a:rPr lang="en-US" smtClean="0"/>
              <a:t>9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1697-5768-FE49-BD9B-0DBB62A91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4760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4750B-DF4D-1C4A-B1E1-4DFC72D2C6DC}" type="datetimeFigureOut">
              <a:rPr lang="en-US" smtClean="0"/>
              <a:t>9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1697-5768-FE49-BD9B-0DBB62A91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17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4750B-DF4D-1C4A-B1E1-4DFC72D2C6DC}" type="datetimeFigureOut">
              <a:rPr lang="en-US" smtClean="0"/>
              <a:t>9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1697-5768-FE49-BD9B-0DBB62A91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59300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4750B-DF4D-1C4A-B1E1-4DFC72D2C6DC}" type="datetimeFigureOut">
              <a:rPr lang="en-US" smtClean="0"/>
              <a:t>9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1697-5768-FE49-BD9B-0DBB62A91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12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4750B-DF4D-1C4A-B1E1-4DFC72D2C6DC}" type="datetimeFigureOut">
              <a:rPr lang="en-US" smtClean="0"/>
              <a:t>9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1697-5768-FE49-BD9B-0DBB62A91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237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4750B-DF4D-1C4A-B1E1-4DFC72D2C6DC}" type="datetimeFigureOut">
              <a:rPr lang="en-US" smtClean="0"/>
              <a:t>9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1697-5768-FE49-BD9B-0DBB62A91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208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4750B-DF4D-1C4A-B1E1-4DFC72D2C6DC}" type="datetimeFigureOut">
              <a:rPr lang="en-US" smtClean="0"/>
              <a:t>9/26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1697-5768-FE49-BD9B-0DBB62A91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642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4750B-DF4D-1C4A-B1E1-4DFC72D2C6DC}" type="datetimeFigureOut">
              <a:rPr lang="en-US" smtClean="0"/>
              <a:t>9/26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1697-5768-FE49-BD9B-0DBB62A91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712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4750B-DF4D-1C4A-B1E1-4DFC72D2C6DC}" type="datetimeFigureOut">
              <a:rPr lang="en-US" smtClean="0"/>
              <a:t>9/26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1697-5768-FE49-BD9B-0DBB62A91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740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4750B-DF4D-1C4A-B1E1-4DFC72D2C6DC}" type="datetimeFigureOut">
              <a:rPr lang="en-US" smtClean="0"/>
              <a:t>9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1697-5768-FE49-BD9B-0DBB62A91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426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C4750B-DF4D-1C4A-B1E1-4DFC72D2C6DC}" type="datetimeFigureOut">
              <a:rPr lang="en-US" smtClean="0"/>
              <a:t>9/26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9A1697-5768-FE49-BD9B-0DBB62A91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9547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C4750B-DF4D-1C4A-B1E1-4DFC72D2C6DC}" type="datetimeFigureOut">
              <a:rPr lang="en-US" smtClean="0"/>
              <a:t>9/26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9A1697-5768-FE49-BD9B-0DBB62A91E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5126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>
            <a:extLst>
              <a:ext uri="{FF2B5EF4-FFF2-40B4-BE49-F238E27FC236}">
                <a16:creationId xmlns:a16="http://schemas.microsoft.com/office/drawing/2014/main" id="{5428A8A8-15FF-6B49-9EBD-80095558FA9C}"/>
              </a:ext>
            </a:extLst>
          </p:cNvPr>
          <p:cNvGrpSpPr/>
          <p:nvPr/>
        </p:nvGrpSpPr>
        <p:grpSpPr>
          <a:xfrm>
            <a:off x="111320" y="220755"/>
            <a:ext cx="3856382" cy="3012803"/>
            <a:chOff x="111320" y="220755"/>
            <a:chExt cx="3856382" cy="3012803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88"/>
            <a:stretch/>
          </p:blipFill>
          <p:spPr>
            <a:xfrm>
              <a:off x="111320" y="220755"/>
              <a:ext cx="3856382" cy="3012803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D302367-4F15-2E43-BB14-3F966B51E2BC}"/>
                </a:ext>
              </a:extLst>
            </p:cNvPr>
            <p:cNvSpPr txBox="1"/>
            <p:nvPr/>
          </p:nvSpPr>
          <p:spPr>
            <a:xfrm>
              <a:off x="899730" y="2889818"/>
              <a:ext cx="97597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Low Altitude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6350670-9A29-394C-8DC7-FBA1DB3303FB}"/>
                </a:ext>
              </a:extLst>
            </p:cNvPr>
            <p:cNvSpPr txBox="1"/>
            <p:nvPr/>
          </p:nvSpPr>
          <p:spPr>
            <a:xfrm>
              <a:off x="2354905" y="2884841"/>
              <a:ext cx="100380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High Altitude</a:t>
              </a:r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35B50894-227B-6F41-BE8A-2BAA36A9CD93}"/>
                </a:ext>
              </a:extLst>
            </p:cNvPr>
            <p:cNvSpPr/>
            <p:nvPr/>
          </p:nvSpPr>
          <p:spPr>
            <a:xfrm>
              <a:off x="1828800" y="2919234"/>
              <a:ext cx="572111" cy="29842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8D2A38BB-AE46-6B4C-B396-4A3D94A58D05}"/>
              </a:ext>
            </a:extLst>
          </p:cNvPr>
          <p:cNvGrpSpPr/>
          <p:nvPr/>
        </p:nvGrpSpPr>
        <p:grpSpPr>
          <a:xfrm>
            <a:off x="3810081" y="380174"/>
            <a:ext cx="3750449" cy="2871875"/>
            <a:chOff x="3810081" y="380174"/>
            <a:chExt cx="3750449" cy="2871875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8" t="1807"/>
            <a:stretch/>
          </p:blipFill>
          <p:spPr>
            <a:xfrm>
              <a:off x="3810081" y="380174"/>
              <a:ext cx="3750449" cy="2837482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005324A-7A46-8A4B-85A0-E51AB1F3D0E4}"/>
                </a:ext>
              </a:extLst>
            </p:cNvPr>
            <p:cNvSpPr txBox="1"/>
            <p:nvPr/>
          </p:nvSpPr>
          <p:spPr>
            <a:xfrm>
              <a:off x="4598491" y="2924211"/>
              <a:ext cx="97597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Low Altitude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50FAA5A-D1A8-744F-A79F-27C9C50D6BAF}"/>
                </a:ext>
              </a:extLst>
            </p:cNvPr>
            <p:cNvSpPr txBox="1"/>
            <p:nvPr/>
          </p:nvSpPr>
          <p:spPr>
            <a:xfrm>
              <a:off x="6053666" y="2919234"/>
              <a:ext cx="100380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High Altitude</a:t>
              </a:r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FDC7C194-04FC-FA4A-B5FF-27DA63C371A1}"/>
                </a:ext>
              </a:extLst>
            </p:cNvPr>
            <p:cNvSpPr/>
            <p:nvPr/>
          </p:nvSpPr>
          <p:spPr>
            <a:xfrm>
              <a:off x="5527561" y="2953627"/>
              <a:ext cx="572111" cy="29842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DAEF0C20-9ABD-764B-9EC2-85C1280889DC}"/>
              </a:ext>
            </a:extLst>
          </p:cNvPr>
          <p:cNvGrpSpPr/>
          <p:nvPr/>
        </p:nvGrpSpPr>
        <p:grpSpPr>
          <a:xfrm>
            <a:off x="169569" y="3377075"/>
            <a:ext cx="3798133" cy="3018304"/>
            <a:chOff x="169569" y="3377075"/>
            <a:chExt cx="3798133" cy="3018304"/>
          </a:xfrm>
        </p:grpSpPr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2" t="1208"/>
            <a:stretch/>
          </p:blipFill>
          <p:spPr>
            <a:xfrm>
              <a:off x="169569" y="3377075"/>
              <a:ext cx="3798133" cy="2905303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2D4B9C5-F77D-904E-80EF-2E8B26792167}"/>
                </a:ext>
              </a:extLst>
            </p:cNvPr>
            <p:cNvSpPr txBox="1"/>
            <p:nvPr/>
          </p:nvSpPr>
          <p:spPr>
            <a:xfrm>
              <a:off x="1015053" y="6067541"/>
              <a:ext cx="97597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Low Altitude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4BCBBC9-2830-7849-8914-EF0F4CBA249D}"/>
                </a:ext>
              </a:extLst>
            </p:cNvPr>
            <p:cNvSpPr txBox="1"/>
            <p:nvPr/>
          </p:nvSpPr>
          <p:spPr>
            <a:xfrm>
              <a:off x="2470228" y="6062564"/>
              <a:ext cx="100380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High Altitude</a:t>
              </a: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04D17E03-D684-194E-9EF5-067FFE8E9A89}"/>
                </a:ext>
              </a:extLst>
            </p:cNvPr>
            <p:cNvSpPr/>
            <p:nvPr/>
          </p:nvSpPr>
          <p:spPr>
            <a:xfrm>
              <a:off x="1944123" y="6096957"/>
              <a:ext cx="572111" cy="29842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7A9B262A-7E7A-B246-BB79-54C044F68919}"/>
              </a:ext>
            </a:extLst>
          </p:cNvPr>
          <p:cNvGrpSpPr/>
          <p:nvPr/>
        </p:nvGrpSpPr>
        <p:grpSpPr>
          <a:xfrm>
            <a:off x="3711544" y="3418377"/>
            <a:ext cx="3947521" cy="2975825"/>
            <a:chOff x="3711544" y="3418377"/>
            <a:chExt cx="3947521" cy="2975825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5" t="509"/>
            <a:stretch/>
          </p:blipFill>
          <p:spPr>
            <a:xfrm>
              <a:off x="3711544" y="3418377"/>
              <a:ext cx="3947521" cy="2898119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3CA70968-413B-CB43-A938-5A8A3AFDE9B6}"/>
                </a:ext>
              </a:extLst>
            </p:cNvPr>
            <p:cNvSpPr txBox="1"/>
            <p:nvPr/>
          </p:nvSpPr>
          <p:spPr>
            <a:xfrm>
              <a:off x="4644497" y="6066364"/>
              <a:ext cx="97597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Low Altitude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6F93322F-75F8-534E-9A25-9BE52236FDF6}"/>
                </a:ext>
              </a:extLst>
            </p:cNvPr>
            <p:cNvSpPr txBox="1"/>
            <p:nvPr/>
          </p:nvSpPr>
          <p:spPr>
            <a:xfrm>
              <a:off x="6099672" y="6061387"/>
              <a:ext cx="100380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High Altitude</a:t>
              </a: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0C5885D6-6A5D-1148-98FF-E013304A2E84}"/>
                </a:ext>
              </a:extLst>
            </p:cNvPr>
            <p:cNvSpPr/>
            <p:nvPr/>
          </p:nvSpPr>
          <p:spPr>
            <a:xfrm>
              <a:off x="5573567" y="6095780"/>
              <a:ext cx="572111" cy="29842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6A16852E-D7A9-7C41-A566-DEC2F39ADC77}"/>
              </a:ext>
            </a:extLst>
          </p:cNvPr>
          <p:cNvGrpSpPr/>
          <p:nvPr/>
        </p:nvGrpSpPr>
        <p:grpSpPr>
          <a:xfrm>
            <a:off x="7560530" y="3418377"/>
            <a:ext cx="3929828" cy="2953935"/>
            <a:chOff x="7560530" y="3418377"/>
            <a:chExt cx="3929828" cy="2953935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60530" y="3418377"/>
              <a:ext cx="3929828" cy="2864001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63E1229-E569-084A-9E83-FEAB80E9F46E}"/>
                </a:ext>
              </a:extLst>
            </p:cNvPr>
            <p:cNvSpPr txBox="1"/>
            <p:nvPr/>
          </p:nvSpPr>
          <p:spPr>
            <a:xfrm>
              <a:off x="8476949" y="6044474"/>
              <a:ext cx="97597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Low Altitude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90F15FD-6B16-5F47-B4B2-6A6F004A284B}"/>
                </a:ext>
              </a:extLst>
            </p:cNvPr>
            <p:cNvSpPr txBox="1"/>
            <p:nvPr/>
          </p:nvSpPr>
          <p:spPr>
            <a:xfrm>
              <a:off x="9932124" y="6039497"/>
              <a:ext cx="100380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High Altitude</a:t>
              </a: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4EA9AB79-FE0A-A34E-9B63-C5F09701CC41}"/>
                </a:ext>
              </a:extLst>
            </p:cNvPr>
            <p:cNvSpPr/>
            <p:nvPr/>
          </p:nvSpPr>
          <p:spPr>
            <a:xfrm>
              <a:off x="9406019" y="6073890"/>
              <a:ext cx="572111" cy="29842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0526571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2939233B-AEBE-E346-9612-D1DDB35F7190}"/>
              </a:ext>
            </a:extLst>
          </p:cNvPr>
          <p:cNvGrpSpPr/>
          <p:nvPr/>
        </p:nvGrpSpPr>
        <p:grpSpPr>
          <a:xfrm>
            <a:off x="317719" y="1203158"/>
            <a:ext cx="5200978" cy="4212925"/>
            <a:chOff x="317719" y="1203158"/>
            <a:chExt cx="5200978" cy="4212925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5089" y="1748590"/>
              <a:ext cx="5103608" cy="3446251"/>
            </a:xfrm>
            <a:prstGeom prst="rect">
              <a:avLst/>
            </a:prstGeom>
          </p:spPr>
        </p:pic>
        <p:sp>
          <p:nvSpPr>
            <p:cNvPr id="2" name="TextBox 1"/>
            <p:cNvSpPr txBox="1"/>
            <p:nvPr/>
          </p:nvSpPr>
          <p:spPr>
            <a:xfrm>
              <a:off x="415089" y="1203158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/>
                <a:t>A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-322039" y="3191074"/>
              <a:ext cx="158729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charset="0"/>
                  <a:ea typeface="Arial" charset="0"/>
                  <a:cs typeface="Arial" charset="0"/>
                </a:rPr>
                <a:t>Hemoglobin, g/</a:t>
              </a:r>
              <a:r>
                <a:rPr lang="en-US" sz="1400" dirty="0" err="1">
                  <a:latin typeface="Arial" charset="0"/>
                  <a:ea typeface="Arial" charset="0"/>
                  <a:cs typeface="Arial" charset="0"/>
                </a:rPr>
                <a:t>dL</a:t>
              </a:r>
              <a:endParaRPr lang="en-US" sz="14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E4DF320-48E7-AF41-A1C1-2A29063D2DC3}"/>
                </a:ext>
              </a:extLst>
            </p:cNvPr>
            <p:cNvSpPr txBox="1"/>
            <p:nvPr/>
          </p:nvSpPr>
          <p:spPr>
            <a:xfrm>
              <a:off x="1919217" y="5046751"/>
              <a:ext cx="2581541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i="1" dirty="0"/>
                <a:t>RXRA</a:t>
              </a:r>
              <a:r>
                <a:rPr lang="en-US" dirty="0"/>
                <a:t> % DNA Methylation</a:t>
              </a:r>
            </a:p>
          </p:txBody>
        </p: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40C49D68-569B-2544-A2D2-528B88F957FF}"/>
              </a:ext>
            </a:extLst>
          </p:cNvPr>
          <p:cNvGrpSpPr/>
          <p:nvPr/>
        </p:nvGrpSpPr>
        <p:grpSpPr>
          <a:xfrm>
            <a:off x="5878388" y="1235606"/>
            <a:ext cx="5842151" cy="4192456"/>
            <a:chOff x="5878388" y="1235606"/>
            <a:chExt cx="5842151" cy="4192456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64360" y="1748590"/>
              <a:ext cx="5656179" cy="3446251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5909510" y="1235606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 rot="16200000">
              <a:off x="4645519" y="3191074"/>
              <a:ext cx="277351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charset="0"/>
                  <a:ea typeface="Arial" charset="0"/>
                  <a:cs typeface="Arial" charset="0"/>
                </a:rPr>
                <a:t>Systolic Blood Pressure (mmHg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B7FC358-EA43-6F41-AFD2-5F0A045DDEA8}"/>
                </a:ext>
              </a:extLst>
            </p:cNvPr>
            <p:cNvSpPr txBox="1"/>
            <p:nvPr/>
          </p:nvSpPr>
          <p:spPr>
            <a:xfrm>
              <a:off x="7952232" y="5058730"/>
              <a:ext cx="2459712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i="1" dirty="0"/>
                <a:t>EPO</a:t>
              </a:r>
              <a:r>
                <a:rPr lang="en-US" dirty="0"/>
                <a:t> % DNA Methylat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421421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3</Words>
  <Application>Microsoft Office PowerPoint</Application>
  <PresentationFormat>Widescreen</PresentationFormat>
  <Paragraphs>2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Angharad Brewer Gillham</cp:lastModifiedBy>
  <cp:revision>6</cp:revision>
  <dcterms:created xsi:type="dcterms:W3CDTF">2019-07-09T17:28:42Z</dcterms:created>
  <dcterms:modified xsi:type="dcterms:W3CDTF">2019-09-26T13:51:46Z</dcterms:modified>
</cp:coreProperties>
</file>